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9" d="100"/>
          <a:sy n="39" d="100"/>
        </p:scale>
        <p:origin x="2357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56C99-19D1-005D-F160-57E6F16AE0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D4AF63-AB00-5565-728E-DA232A6367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3F028-1BD3-DB1A-849E-6750FEDE0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2CED81-DDBE-A769-668A-5CCAC71B2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81F4B3-3A90-12FA-14E0-138E4D4F3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512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1FEDB3-A8E1-0A82-0A9F-68A00E6C78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0AEDD0-CC39-B9AD-AA76-492D950A47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C37507-F0F9-8F24-A930-6F4D8D8E8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08E1A4-D12C-A309-37BA-E36B78490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799D1D-D005-548F-4936-FDD9A71EC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510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B3D070-51BB-8AED-3CC6-5A24FAC897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621184-29F6-D47A-BA7B-A57997E0BB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5E758E-EA42-60A3-D363-0EE164CFA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AA2A49-C585-7240-71F4-BB6B404D3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AA057-DCA7-E069-084F-16479FEF3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281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CB9D3-4DB8-4304-AB8C-9F70377DF0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2DC535-FAF9-28A4-5B17-DEAAFB5E3F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3666F-2672-06A2-70DD-E4DDECA49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1CA8C-C9EB-DCE9-9375-C51E0482E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15F30-A45B-99D2-2C60-598FD8169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9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D25E0-55D9-56F7-B02E-EF530DC7C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0EF2A2-B622-AFCE-4726-5C02C456AA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77DD91-04A5-CCCB-5284-5ACD51C4B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2F190-10AC-1072-0172-D225F4C5C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F5638D-9E87-1D1D-6336-700807E9F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260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84DA7-D105-CDCB-9F5B-1942D58F3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D38D0D-8CB0-F927-03CF-844F2B6CB2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DC3C81-9D48-27A4-6B5F-7A328AE21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DB5119-0773-E344-29B4-67557C61D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AD9568-6350-98FC-DBB8-DEA14370E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876F25-A247-A6B2-9CD1-08645ABB0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5075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2DDB3-5551-8FAE-3270-8DAA554F2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090F25-7E36-1602-C72E-0BC4B568C2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E25B22-CB4D-7182-9DBE-CE75BBE816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22DA74-DE81-CAA3-5E49-C9B4F67E16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8553FF-2508-EBCE-DA0E-955E1004C1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6598A9-5FCC-CDF0-3CCD-14A8B5735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034E2A-5C3B-B0F3-1B7C-153C96874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1F7F2D-9578-8779-9C4B-A1F34F52D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751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10775-AC12-7B8D-F16B-CF4149F64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AE2314-E0B7-49C5-4DD3-EDB88470A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53FF9C-1DA5-A880-D222-A84726CD5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1E3EAD-D692-BB9A-2499-F3C2C7700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515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D7FDCE-C277-CF27-63EC-7ACDB3C77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9F315C-C2C5-986E-A850-D6C8C97D5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1FECC4-4405-AC6C-14DF-CECC74C4A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312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D7177-C759-2BD8-EB4E-7AEFEA01F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88FD0B-7CA0-D371-F871-C41826DD95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658646-9398-4EEC-A656-EC7EF77E7D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9FBFAA-327A-2481-722E-FA2484886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88057-C902-8499-E033-5DBC947FD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8F5F8E-383A-F423-3C10-FBB664546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859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C8D7E-034B-693A-CE88-F1DDF393B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E5A04E-ECA6-DF02-A6DA-EB532DE853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F4F617-5A54-634B-E82E-1E45FD56D5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04BFF4-BF34-330B-3FA8-812B7F537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FA5FDD-58FD-9EDE-99C9-DEDB8B7A0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B92E7B-1054-1307-A736-9FCD7EE8B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31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CA38A1-F039-CD41-99E9-66D0A1F416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843905-7A87-D285-8F6B-3AE51119ED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5DCB6-E64E-20A9-D3DF-6425A7A779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4A07EA-4764-43D6-BAC6-B8AE4816B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BBD78-BD33-8BF8-F27A-3568A93586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A95D94-BFD8-3BCD-9332-23EFA7F22F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4729B2-C67A-47FE-B9E4-9D89029878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434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6A3C5B-9FBD-D837-0D1B-A72A9FC0F106}"/>
              </a:ext>
            </a:extLst>
          </p:cNvPr>
          <p:cNvSpPr txBox="1"/>
          <p:nvPr/>
        </p:nvSpPr>
        <p:spPr>
          <a:xfrm>
            <a:off x="0" y="97277"/>
            <a:ext cx="23189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 n1</a:t>
            </a:r>
          </a:p>
        </p:txBody>
      </p:sp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CF385361-C758-EBA3-3333-1C4C465F15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09" y="374276"/>
            <a:ext cx="5383872" cy="4303451"/>
          </a:xfrm>
          <a:prstGeom prst="rect">
            <a:avLst/>
          </a:prstGeom>
        </p:spPr>
      </p:pic>
      <p:pic>
        <p:nvPicPr>
          <p:cNvPr id="8" name="Picture 7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7B8F73D4-3984-83AA-9646-CBF8C933D4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8997" y="543222"/>
            <a:ext cx="5519053" cy="4411504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9CF598E4-DD1B-485E-B246-B45C7DDFA5D5}"/>
              </a:ext>
            </a:extLst>
          </p:cNvPr>
          <p:cNvSpPr/>
          <p:nvPr/>
        </p:nvSpPr>
        <p:spPr>
          <a:xfrm>
            <a:off x="3067845" y="2626468"/>
            <a:ext cx="1115684" cy="23346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48EBDE-46B0-D5BA-117F-539AE705BF2A}"/>
              </a:ext>
            </a:extLst>
          </p:cNvPr>
          <p:cNvSpPr txBox="1"/>
          <p:nvPr/>
        </p:nvSpPr>
        <p:spPr>
          <a:xfrm>
            <a:off x="4183529" y="2629100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1BABD3B-6F99-A237-7533-FDBC1C3767DF}"/>
              </a:ext>
            </a:extLst>
          </p:cNvPr>
          <p:cNvSpPr/>
          <p:nvPr/>
        </p:nvSpPr>
        <p:spPr>
          <a:xfrm>
            <a:off x="8077777" y="2796136"/>
            <a:ext cx="955532" cy="21516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AEB563-4017-DEB4-8D34-FC3BA3D72DB1}"/>
              </a:ext>
            </a:extLst>
          </p:cNvPr>
          <p:cNvSpPr txBox="1"/>
          <p:nvPr/>
        </p:nvSpPr>
        <p:spPr>
          <a:xfrm>
            <a:off x="9042898" y="2780607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>
                <a:solidFill>
                  <a:srgbClr val="FF0000"/>
                </a:solidFill>
              </a:rPr>
              <a:t>β</a:t>
            </a:r>
            <a:r>
              <a:rPr lang="en-GB" sz="1000" dirty="0">
                <a:solidFill>
                  <a:srgbClr val="FF0000"/>
                </a:solidFill>
              </a:rPr>
              <a:t>-tubulin</a:t>
            </a:r>
          </a:p>
        </p:txBody>
      </p:sp>
    </p:spTree>
    <p:extLst>
      <p:ext uri="{BB962C8B-B14F-4D97-AF65-F5344CB8AC3E}">
        <p14:creationId xmlns:p14="http://schemas.microsoft.com/office/powerpoint/2010/main" val="1050237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6CB0C83-6B30-568A-EC5A-A906B3A548D4}"/>
              </a:ext>
            </a:extLst>
          </p:cNvPr>
          <p:cNvSpPr txBox="1"/>
          <p:nvPr/>
        </p:nvSpPr>
        <p:spPr>
          <a:xfrm>
            <a:off x="0" y="97277"/>
            <a:ext cx="23189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 n2</a:t>
            </a:r>
          </a:p>
        </p:txBody>
      </p:sp>
      <p:pic>
        <p:nvPicPr>
          <p:cNvPr id="6" name="Picture 5" descr="A close-up of a dna test&#10;&#10;Description automatically generated">
            <a:extLst>
              <a:ext uri="{FF2B5EF4-FFF2-40B4-BE49-F238E27FC236}">
                <a16:creationId xmlns:a16="http://schemas.microsoft.com/office/drawing/2014/main" id="{010C2D04-B027-48C6-4C48-74D1355F0C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952" y="848438"/>
            <a:ext cx="5503175" cy="4396027"/>
          </a:xfrm>
          <a:prstGeom prst="rect">
            <a:avLst/>
          </a:prstGeom>
        </p:spPr>
      </p:pic>
      <p:pic>
        <p:nvPicPr>
          <p:cNvPr id="8" name="Picture 7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3C1CC512-50A7-4A60-EB0D-C7637212F1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5490" y="495604"/>
            <a:ext cx="5631391" cy="450129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798DE33-B827-42BE-A983-FD4DDD4F2D2F}"/>
              </a:ext>
            </a:extLst>
          </p:cNvPr>
          <p:cNvSpPr txBox="1"/>
          <p:nvPr/>
        </p:nvSpPr>
        <p:spPr>
          <a:xfrm>
            <a:off x="1464758" y="2500032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9720E65-C9D3-CB9F-F732-C6D78B32B9A9}"/>
              </a:ext>
            </a:extLst>
          </p:cNvPr>
          <p:cNvSpPr txBox="1"/>
          <p:nvPr/>
        </p:nvSpPr>
        <p:spPr>
          <a:xfrm>
            <a:off x="6202598" y="2376920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>
                <a:solidFill>
                  <a:srgbClr val="FF0000"/>
                </a:solidFill>
              </a:rPr>
              <a:t>β</a:t>
            </a:r>
            <a:r>
              <a:rPr lang="en-GB" sz="1000" dirty="0">
                <a:solidFill>
                  <a:srgbClr val="FF0000"/>
                </a:solidFill>
              </a:rPr>
              <a:t>-tubuli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B631EC4-1A29-4087-1678-B6C135CBDF4D}"/>
              </a:ext>
            </a:extLst>
          </p:cNvPr>
          <p:cNvSpPr/>
          <p:nvPr/>
        </p:nvSpPr>
        <p:spPr>
          <a:xfrm>
            <a:off x="2057399" y="2500032"/>
            <a:ext cx="1171575" cy="24622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2406852-BC74-CDB2-5766-243C62FFAB4B}"/>
              </a:ext>
            </a:extLst>
          </p:cNvPr>
          <p:cNvSpPr/>
          <p:nvPr/>
        </p:nvSpPr>
        <p:spPr>
          <a:xfrm>
            <a:off x="6967933" y="2376920"/>
            <a:ext cx="1171575" cy="24622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685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4237A8-5FC6-869D-03AD-89E6C7171A4A}"/>
              </a:ext>
            </a:extLst>
          </p:cNvPr>
          <p:cNvSpPr txBox="1"/>
          <p:nvPr/>
        </p:nvSpPr>
        <p:spPr>
          <a:xfrm>
            <a:off x="0" y="97277"/>
            <a:ext cx="23189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 n3</a:t>
            </a:r>
          </a:p>
        </p:txBody>
      </p:sp>
      <p:pic>
        <p:nvPicPr>
          <p:cNvPr id="5" name="Picture 4" descr="A picture containing sketch, white, black, black and white&#10;&#10;Description automatically generated">
            <a:extLst>
              <a:ext uri="{FF2B5EF4-FFF2-40B4-BE49-F238E27FC236}">
                <a16:creationId xmlns:a16="http://schemas.microsoft.com/office/drawing/2014/main" id="{B6458C2F-B2D7-085F-B0E9-4F1999A8C5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0" t="-3058" r="-420" b="-278"/>
          <a:stretch/>
        </p:blipFill>
        <p:spPr>
          <a:xfrm>
            <a:off x="0" y="1030078"/>
            <a:ext cx="7723761" cy="2096550"/>
          </a:xfrm>
          <a:prstGeom prst="rect">
            <a:avLst/>
          </a:prstGeom>
          <a:ln>
            <a:noFill/>
          </a:ln>
        </p:spPr>
      </p:pic>
      <p:pic>
        <p:nvPicPr>
          <p:cNvPr id="6" name="Picture 5" descr="A picture containing sketch, black, white, black and white&#10;&#10;Description automatically generated">
            <a:extLst>
              <a:ext uri="{FF2B5EF4-FFF2-40B4-BE49-F238E27FC236}">
                <a16:creationId xmlns:a16="http://schemas.microsoft.com/office/drawing/2014/main" id="{4F830CA5-5EC4-5285-E9CE-B515DE76C4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4" t="-64" r="-173" b="-6317"/>
          <a:stretch/>
        </p:blipFill>
        <p:spPr>
          <a:xfrm>
            <a:off x="1067905" y="2933907"/>
            <a:ext cx="6974732" cy="1750979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13EDFAC-4B3A-9A39-7985-3FA2337922CF}"/>
              </a:ext>
            </a:extLst>
          </p:cNvPr>
          <p:cNvSpPr txBox="1"/>
          <p:nvPr/>
        </p:nvSpPr>
        <p:spPr>
          <a:xfrm>
            <a:off x="5940346" y="1858882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AB10E1-581B-AF98-1CEA-61A783DC9E68}"/>
              </a:ext>
            </a:extLst>
          </p:cNvPr>
          <p:cNvSpPr txBox="1"/>
          <p:nvPr/>
        </p:nvSpPr>
        <p:spPr>
          <a:xfrm>
            <a:off x="5940346" y="3659318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>
                <a:solidFill>
                  <a:srgbClr val="FF0000"/>
                </a:solidFill>
              </a:rPr>
              <a:t>β</a:t>
            </a:r>
            <a:r>
              <a:rPr lang="en-GB" sz="1000" dirty="0">
                <a:solidFill>
                  <a:srgbClr val="FF0000"/>
                </a:solidFill>
              </a:rPr>
              <a:t>-tubuli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930DE03-27AB-D672-6B7F-FFBDB272D329}"/>
              </a:ext>
            </a:extLst>
          </p:cNvPr>
          <p:cNvSpPr/>
          <p:nvPr/>
        </p:nvSpPr>
        <p:spPr>
          <a:xfrm>
            <a:off x="4555271" y="1858882"/>
            <a:ext cx="1332572" cy="24622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84F1766-476F-2918-C64A-AE79B47BCF08}"/>
              </a:ext>
            </a:extLst>
          </p:cNvPr>
          <p:cNvSpPr/>
          <p:nvPr/>
        </p:nvSpPr>
        <p:spPr>
          <a:xfrm>
            <a:off x="4622982" y="3659319"/>
            <a:ext cx="1332572" cy="24622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301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30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1</cp:revision>
  <dcterms:created xsi:type="dcterms:W3CDTF">2024-08-31T21:15:06Z</dcterms:created>
  <dcterms:modified xsi:type="dcterms:W3CDTF">2024-08-31T21:50:43Z</dcterms:modified>
</cp:coreProperties>
</file>